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media/image1.wmf" ContentType="image/x-wmf"/>
  <Override PartName="/ppt/media/image2.wmf" ContentType="image/x-wmf"/>
  <Override PartName="/ppt/media/image3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907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52560" y="685440"/>
            <a:ext cx="495288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A065D83-84D2-4AC6-88C4-CADB0A9C3F92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sldImg"/>
          </p:nvPr>
        </p:nvSpPr>
        <p:spPr>
          <a:xfrm>
            <a:off x="952560" y="685800"/>
            <a:ext cx="4952880" cy="3429000"/>
          </a:xfrm>
          <a:prstGeom prst="rect">
            <a:avLst/>
          </a:prstGeom>
          <a:ln w="0">
            <a:noFill/>
          </a:ln>
        </p:spPr>
      </p:sp>
      <p:sp>
        <p:nvSpPr>
          <p:cNvPr id="5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5E9A1EA-4B60-4F44-B872-E99BA061C695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B498EA-ECD6-4F68-9780-72C7F24003F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A9D5C5-B67B-4C2E-86FE-98ECDBE9ED6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94AF89-8A12-4095-B68C-61177F85358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0964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52428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9500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0964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52428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7C25D8-B970-4467-8620-B916CD6C5A1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6115E6-4CF5-4DC8-BCB6-E74FB371D5D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DF3D6B-076C-46E5-B69C-DE52A56D0C1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306891-719B-41EF-A524-3A3CFEAF054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B3241E-004C-40E1-827E-3B295492C61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95000" y="274320"/>
            <a:ext cx="8915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745420-A6AD-4893-BBD0-F9D239775F3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37EC14-F440-401D-A3D4-92897617F50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843E16-587C-46C1-95C0-C86982B4554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782140-4132-4976-9DB6-763C86ACCD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95360" y="6356520"/>
            <a:ext cx="2311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384360" y="6356520"/>
            <a:ext cx="31366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098840" y="6356520"/>
            <a:ext cx="23115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1F38CF4-9656-4AC5-931B-0E6A71D3D5C9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wmf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Object 2"/>
          <p:cNvGraphicFramePr/>
          <p:nvPr/>
        </p:nvGraphicFramePr>
        <p:xfrm>
          <a:off x="355680" y="522360"/>
          <a:ext cx="3512880" cy="425268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9" name="Object 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55680" y="522360"/>
                    <a:ext cx="3512880" cy="4252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0" name="Object 3"/>
          <p:cNvGraphicFramePr/>
          <p:nvPr/>
        </p:nvGraphicFramePr>
        <p:xfrm>
          <a:off x="3156120" y="515880"/>
          <a:ext cx="3512880" cy="425304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51" name="Object 3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3156120" y="515880"/>
                    <a:ext cx="3512880" cy="4253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2" name="Object 4"/>
          <p:cNvGraphicFramePr/>
          <p:nvPr/>
        </p:nvGraphicFramePr>
        <p:xfrm>
          <a:off x="6002280" y="511200"/>
          <a:ext cx="3487680" cy="426888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53" name="Object 4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6002280" y="511200"/>
                    <a:ext cx="3487680" cy="42688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4" name=""/>
          <p:cNvSpPr/>
          <p:nvPr/>
        </p:nvSpPr>
        <p:spPr>
          <a:xfrm>
            <a:off x="415800" y="5307120"/>
            <a:ext cx="907920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dditional data file 4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The absence of MUP isoforms in the upper mass range of ESI-MS spectra of inbred mouse urine samples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Black lines show spectra for each individual samples within (A) B6 males (n = 5), (B) B6 females (n = 8), (C) BALB/c males (n = 5), (D) BALB/c females (n = 7), (E) 129S5 males (n = 2), (F) 129S5 females (n = 2). Black arrows indicate predicted masses from the B6 or 129 genome analysis. Note the greater baseline noise in female 129S5 samples which were of lower intensity than other samples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3-11T23:21:40Z</dcterms:created>
  <dc:creator>anon</dc:creator>
  <dc:description/>
  <dc:language>en-US</dc:language>
  <cp:lastModifiedBy>jm12</cp:lastModifiedBy>
  <dcterms:modified xsi:type="dcterms:W3CDTF">2008-05-28T09:06:32Z</dcterms:modified>
  <cp:revision>18</cp:revision>
  <dc:subject/>
  <dc:title>Slide 1</dc:title>
</cp:coreProperties>
</file>